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435" r:id="rId2"/>
    <p:sldId id="27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/>
              <a:t>By A</a:t>
            </a:r>
            <a:r>
              <a:rPr lang="en-US" sz="1800" baseline="0"/>
              <a:t>ge Group</a:t>
            </a:r>
            <a:endParaRPr lang="en-US" sz="1800"/>
          </a:p>
        </c:rich>
      </c:tx>
      <c:layout>
        <c:manualLayout>
          <c:xMode val="edge"/>
          <c:yMode val="edge"/>
          <c:x val="0.36983764935284191"/>
          <c:y val="1.56814936355155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group_fig!$A$9:$A$12</c:f>
              <c:strCache>
                <c:ptCount val="4"/>
                <c:pt idx="0">
                  <c:v>18-30 </c:v>
                </c:pt>
                <c:pt idx="1">
                  <c:v>31-50 </c:v>
                </c:pt>
                <c:pt idx="2">
                  <c:v>51-64 </c:v>
                </c:pt>
                <c:pt idx="3">
                  <c:v>≥65 </c:v>
                </c:pt>
              </c:strCache>
            </c:strRef>
          </c:cat>
          <c:val>
            <c:numRef>
              <c:f>Agegroup_fig!$B$9:$B$12</c:f>
              <c:numCache>
                <c:formatCode>0%</c:formatCode>
                <c:ptCount val="4"/>
                <c:pt idx="0">
                  <c:v>0.21309371518177692</c:v>
                </c:pt>
                <c:pt idx="1">
                  <c:v>0.29541846572830349</c:v>
                </c:pt>
                <c:pt idx="2">
                  <c:v>0.46526287091775237</c:v>
                </c:pt>
                <c:pt idx="3">
                  <c:v>0.5629460772341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25-BC48-8E6D-82D277A4F3B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57634832"/>
        <c:axId val="757631224"/>
      </c:barChart>
      <c:catAx>
        <c:axId val="7576348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Year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1224"/>
        <c:crosses val="autoZero"/>
        <c:auto val="1"/>
        <c:lblAlgn val="ctr"/>
        <c:lblOffset val="100"/>
        <c:noMultiLvlLbl val="0"/>
      </c:catAx>
      <c:valAx>
        <c:axId val="757631224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Treatment Rat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alpha val="98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4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aseline="0"/>
              <a:t>By FIB-4 Score</a:t>
            </a:r>
            <a:endParaRPr lang="en-US" sz="1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0AD47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group_fig!$A$2:$A$4</c:f>
              <c:strCache>
                <c:ptCount val="3"/>
                <c:pt idx="0">
                  <c:v>&lt;1.45</c:v>
                </c:pt>
                <c:pt idx="1">
                  <c:v>1.45-3.25</c:v>
                </c:pt>
                <c:pt idx="2">
                  <c:v>&gt;3.25</c:v>
                </c:pt>
              </c:strCache>
            </c:strRef>
          </c:cat>
          <c:val>
            <c:numRef>
              <c:f>Agegroup_fig!$B$2:$B$4</c:f>
              <c:numCache>
                <c:formatCode>0%</c:formatCode>
                <c:ptCount val="3"/>
                <c:pt idx="0">
                  <c:v>0.33600000000000002</c:v>
                </c:pt>
                <c:pt idx="1">
                  <c:v>0.42799999999999999</c:v>
                </c:pt>
                <c:pt idx="2">
                  <c:v>0.465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44-4258-BD11-4635EAD320D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57634832"/>
        <c:axId val="757631224"/>
      </c:barChart>
      <c:catAx>
        <c:axId val="757634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1224"/>
        <c:crosses val="autoZero"/>
        <c:auto val="1"/>
        <c:lblAlgn val="ctr"/>
        <c:lblOffset val="100"/>
        <c:noMultiLvlLbl val="0"/>
      </c:catAx>
      <c:valAx>
        <c:axId val="757631224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/>
                  <a:t>Treatment rate (%)</a:t>
                </a:r>
                <a:endParaRPr lang="en-US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4832"/>
        <c:crosses val="autoZero"/>
        <c:crossBetween val="between"/>
        <c:majorUnit val="0.1"/>
        <c:minorUnit val="1.0000000000000002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aseline="0"/>
              <a:t>By HIV Co-Infection status</a:t>
            </a:r>
            <a:endParaRPr lang="en-US" sz="1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E97132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group_fig!$A$2:$A$3</c:f>
              <c:strCache>
                <c:ptCount val="2"/>
                <c:pt idx="0">
                  <c:v>HIV Positive</c:v>
                </c:pt>
                <c:pt idx="1">
                  <c:v>HIV Negative</c:v>
                </c:pt>
              </c:strCache>
            </c:strRef>
          </c:cat>
          <c:val>
            <c:numRef>
              <c:f>Agegroup_fig!$B$2:$B$3</c:f>
              <c:numCache>
                <c:formatCode>0%</c:formatCode>
                <c:ptCount val="2"/>
                <c:pt idx="0">
                  <c:v>0.625</c:v>
                </c:pt>
                <c:pt idx="1">
                  <c:v>0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00-4829-AF61-C146EB84F558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57634832"/>
        <c:axId val="757631224"/>
      </c:barChart>
      <c:catAx>
        <c:axId val="757634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1224"/>
        <c:crosses val="autoZero"/>
        <c:auto val="1"/>
        <c:lblAlgn val="ctr"/>
        <c:lblOffset val="100"/>
        <c:noMultiLvlLbl val="0"/>
      </c:catAx>
      <c:valAx>
        <c:axId val="7576312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/>
                  <a:t>Treatment rate (%)</a:t>
                </a:r>
                <a:endParaRPr lang="en-US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634832"/>
        <c:crosses val="autoZero"/>
        <c:crossBetween val="between"/>
        <c:majorUnit val="0.1"/>
        <c:minorUnit val="1.0000000000000002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B85C-0058-BF4B-B6C9-7C77070FF967}" type="datetimeFigureOut">
              <a:rPr lang="en-US" smtClean="0"/>
              <a:t>7/23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256602-C5E5-0346-96F2-286258968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17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9185B0-8F90-9C4F-BBC4-74FF82940EE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8753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58424C-89C7-4898-9DA8-8D3F56EBF1C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936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84222-E451-B861-EC9E-F04E899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12A229-79A0-C43A-D305-0EDC9FDEDF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783B1-465F-02DD-8406-5689EB697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59538-C16B-CABB-D059-549FB99E4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1AE8B-1A4B-97BD-C21B-87CDBA6E7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475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F1CB6-8A07-10DC-8A10-1F718EC15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AB0ECE-6FD2-E182-AEB7-940E732678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97E4D0-FCBE-01B2-5651-9455594F4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9E8CB-CE62-BF98-54D5-7893C526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3F4EFD-146E-243B-034C-9E6BC51BF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201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1D7345-B8B8-049C-F737-6290A99414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4F463B-D668-3C7E-DE22-44F9CF4A45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2EF9B1-FAE3-5675-58E1-56D1A6289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E2C316-AFBB-6032-FEDD-9CE4F5685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C7C67-3C8F-AC82-833B-BD460244C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441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1EAEAE-4520-DC57-F8DE-9A0DD913F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10BC3B-C1F9-3FB1-7351-679B82CE58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1A342-9368-051B-5470-08B255C61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8ECA-0520-3351-7AF9-6437ED9C1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06F9D5-5258-8A45-D8D3-89E7FC977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790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EFB833-8862-F410-9416-09148B668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76F355-3315-D98B-7CE1-B3E21DB3AD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D83ED-B924-9D62-4436-F8E373C97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0174C-153B-22A1-9932-8E656ED91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925291-7B08-7AEC-1948-8AD066BD5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74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598C9-6523-D17A-83A2-9E64034193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20A91-D2F0-7CF1-3979-062F7BCE09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3C7240-C95D-695A-AB2E-75E54C22F0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CAC7E2-3CED-5703-DA4E-8B0AB42F5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989BDD-926C-0BCD-202B-054DB3D5E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726128-B787-F0B0-01CC-56CB01A67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848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C856AA-8A4C-007E-C7C4-33ECD9651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067415-BFA2-8F53-189E-621E66994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279A0F-EC55-6DFF-B8D0-AF6470E718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D8DFC4-3FA5-456F-CF12-5C92E6CADD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AC43C3-4C67-5EEA-DFD1-885D21CB23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B76DB7-B02E-9CAD-72BD-7135E2DD8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3AE0CA-3435-6252-7E9A-70E0E4996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009C06-8BB5-EA73-C9FD-520CC47FA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173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C54DD-6368-EB52-45CC-26A24A4A57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395584-5309-BAA5-7E4D-FE2DF83EC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15CD64-C00F-B193-1296-50149A33C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EEE67B-B139-6562-F311-F818ADDBC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609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BEE0B7-D83E-C618-0B6A-64866C611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4D9106-9D20-9A87-FD92-38B69A4E9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A014DF-F847-0548-0520-81DBB60B9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97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F1EF5-6ACB-1372-1F17-66DC42D71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B5BE52-812D-BD88-89A8-8BA1DC05CE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F17FB7-33D6-9942-625D-8B47DC56F2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20157-44E4-39A5-52BD-FAE34A4F4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173D46-ACEC-6A6C-EF01-FDE91D1C3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31BA18-AB82-32AA-D872-2A89246E3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182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9204B-26B9-2F41-E777-67510EE43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073E90-11AF-0F08-DAF7-641EF8432E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F6651F-815E-D010-F9C2-16B8772A8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E1853-2ED7-F9F3-E435-986B50065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BF60D7-0FAC-56FC-76A5-74C9F3920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75F398-ACB9-A9E3-4FB8-4241DA92F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2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8E1111-DB5E-417B-9406-20AD236969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C27F29-DDCD-941F-0568-3D271670A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3B259-BAA7-4B45-50A7-96E85CEA09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02052E-BF27-224E-A059-C840D307891F}" type="datetimeFigureOut">
              <a:rPr lang="en-US" smtClean="0"/>
              <a:t>7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32A96-C0DF-9E24-B3EE-BD7CA1EEC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7513C4-6343-EC0C-1054-6F9BBFCE2D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72EBE-7174-0A44-BC05-A58A746FD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657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EB3181C-8B30-4F14-9079-B8A0394DD575}"/>
              </a:ext>
            </a:extLst>
          </p:cNvPr>
          <p:cNvGraphicFramePr/>
          <p:nvPr/>
        </p:nvGraphicFramePr>
        <p:xfrm>
          <a:off x="148590" y="2096665"/>
          <a:ext cx="3761840" cy="3984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CC712EF0-69D8-A158-CCBD-F47C0695C483}"/>
              </a:ext>
            </a:extLst>
          </p:cNvPr>
          <p:cNvGraphicFramePr/>
          <p:nvPr/>
        </p:nvGraphicFramePr>
        <p:xfrm>
          <a:off x="3815180" y="1884895"/>
          <a:ext cx="3917506" cy="3886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Title 10">
            <a:extLst>
              <a:ext uri="{FF2B5EF4-FFF2-40B4-BE49-F238E27FC236}">
                <a16:creationId xmlns:a16="http://schemas.microsoft.com/office/drawing/2014/main" id="{AF08D1EA-DC94-C863-D3D0-8106990EDE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8454" y="777241"/>
            <a:ext cx="10515600" cy="617838"/>
          </a:xfrm>
        </p:spPr>
        <p:txBody>
          <a:bodyPr>
            <a:normAutofit fontScale="90000"/>
          </a:bodyPr>
          <a:lstStyle/>
          <a:p>
            <a:pPr>
              <a:spcBef>
                <a:spcPts val="600"/>
              </a:spcBef>
            </a:pPr>
            <a:r>
              <a:rPr lang="en-US" sz="1800" dirty="0"/>
              <a:t>Supplementary Figure 1a. HCV treatment rates</a:t>
            </a:r>
            <a:r>
              <a:rPr lang="en-US" sz="1800" baseline="0" dirty="0"/>
              <a:t> among RNA-positive patients by age</a:t>
            </a:r>
            <a:r>
              <a:rPr lang="en-US" sz="1800" dirty="0"/>
              <a:t>, 2014-2021</a:t>
            </a:r>
            <a:br>
              <a:rPr lang="en-US" sz="1800" dirty="0"/>
            </a:br>
            <a:r>
              <a:rPr lang="en-US" sz="1800" dirty="0"/>
              <a:t>Supplementary Figure 1b. HCV treatment rates </a:t>
            </a:r>
            <a:r>
              <a:rPr lang="en-US" sz="1800" baseline="0" dirty="0"/>
              <a:t>by FIB-4 </a:t>
            </a:r>
            <a:r>
              <a:rPr lang="en-US" sz="1800" dirty="0"/>
              <a:t>score, 2014-2021</a:t>
            </a:r>
            <a:br>
              <a:rPr lang="en-US" sz="1800" dirty="0"/>
            </a:br>
            <a:r>
              <a:rPr lang="en-US" sz="1800" dirty="0"/>
              <a:t>Supplementary Figure 1c. HCV treatment rates by HIV co-infection status, 2014-2021</a:t>
            </a:r>
            <a:br>
              <a:rPr lang="en-US" sz="1800" dirty="0"/>
            </a:br>
            <a:endParaRPr lang="en-US" sz="1800" dirty="0"/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C422E0C9-E5B0-2F7C-AC3E-0F2C5D5B08D4}"/>
              </a:ext>
            </a:extLst>
          </p:cNvPr>
          <p:cNvGraphicFramePr/>
          <p:nvPr/>
        </p:nvGraphicFramePr>
        <p:xfrm>
          <a:off x="7909618" y="1884895"/>
          <a:ext cx="4052577" cy="3886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813920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1789" y="212777"/>
            <a:ext cx="10881089" cy="565965"/>
          </a:xfrm>
        </p:spPr>
        <p:txBody>
          <a:bodyPr>
            <a:normAutofit/>
          </a:bodyPr>
          <a:lstStyle/>
          <a:p>
            <a:r>
              <a:rPr lang="en-US" sz="1800"/>
              <a:t>Supplementary Figure 2. Percentage of the HCV RNA-Positive Patients Treated in 202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5E22015-E6D7-8978-679A-2190BEF8EE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0184" y="1260730"/>
            <a:ext cx="8004298" cy="457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190AE1B-1C61-305F-0D00-581E1C56FD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86174" y="5831778"/>
            <a:ext cx="5604970" cy="260454"/>
          </a:xfrm>
          <a:prstGeom prst="rect">
            <a:avLst/>
          </a:prstGeom>
        </p:spPr>
      </p:pic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87651C1-78A2-4C7C-8367-DEA4909F065A}"/>
              </a:ext>
            </a:extLst>
          </p:cNvPr>
          <p:cNvSpPr txBox="1">
            <a:spLocks/>
          </p:cNvSpPr>
          <p:nvPr/>
        </p:nvSpPr>
        <p:spPr>
          <a:xfrm>
            <a:off x="3866438" y="1046896"/>
            <a:ext cx="4444442" cy="55399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sz="1800" b="1" noProof="0">
                <a:solidFill>
                  <a:srgbClr val="071D49"/>
                </a:solidFill>
                <a:latin typeface="Arial"/>
              </a:rPr>
              <a:t>N</a:t>
            </a: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srgbClr val="071D49"/>
                </a:solidFill>
                <a:effectLst/>
                <a:uLnTx/>
                <a:uFillTx/>
                <a:latin typeface="Arial"/>
              </a:rPr>
              <a:t>ational Average = 21.1%</a:t>
            </a:r>
          </a:p>
          <a:p>
            <a:pPr marL="0" marR="0" lvl="0" indent="0" algn="ctr" defTabSz="4572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sz="1800" b="1">
                <a:solidFill>
                  <a:srgbClr val="071D49"/>
                </a:solidFill>
                <a:latin typeface="Arial"/>
              </a:rPr>
              <a:t>Range by state: 10.9% - 33%</a:t>
            </a:r>
            <a:endParaRPr kumimoji="0" lang="en-US" sz="1800" b="1" i="0" u="none" strike="noStrike" kern="1200" cap="none" spc="0" normalizeH="0" baseline="0" noProof="0">
              <a:ln>
                <a:noFill/>
              </a:ln>
              <a:solidFill>
                <a:srgbClr val="071D49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5A33E5-6BAC-4207-994E-3C9C79828A27}"/>
              </a:ext>
            </a:extLst>
          </p:cNvPr>
          <p:cNvSpPr txBox="1"/>
          <p:nvPr/>
        </p:nvSpPr>
        <p:spPr>
          <a:xfrm>
            <a:off x="397080" y="6212245"/>
            <a:ext cx="9780383" cy="33855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Malgun Gothic"/>
                <a:cs typeface="Arial" panose="020B0604020202020204" pitchFamily="34" charset="0"/>
              </a:rPr>
              <a:t>Receipt of treatment was determined based on a viral load decline of at least 1.2 × log10 units since the first positive HCV RNA test, indicating that treatment was initiated in the immediate period prior to the decline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ED6EDE9-3B62-4B84-DA64-6957C97E4DC7}"/>
              </a:ext>
            </a:extLst>
          </p:cNvPr>
          <p:cNvGrpSpPr/>
          <p:nvPr/>
        </p:nvGrpSpPr>
        <p:grpSpPr>
          <a:xfrm>
            <a:off x="2844165" y="1625134"/>
            <a:ext cx="7062675" cy="3321263"/>
            <a:chOff x="3377565" y="2459306"/>
            <a:chExt cx="7062675" cy="3321263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21D7A84-9F74-C87B-55ED-D2A7694EDAD8}"/>
                </a:ext>
              </a:extLst>
            </p:cNvPr>
            <p:cNvSpPr/>
            <p:nvPr/>
          </p:nvSpPr>
          <p:spPr>
            <a:xfrm>
              <a:off x="3514725" y="2459306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WA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E27E3B95-997F-6764-0C51-97CC56A2355A}"/>
                </a:ext>
              </a:extLst>
            </p:cNvPr>
            <p:cNvSpPr/>
            <p:nvPr/>
          </p:nvSpPr>
          <p:spPr>
            <a:xfrm>
              <a:off x="3377565" y="2951749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OR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3994BB7-57F6-723D-31E6-449CC0282F11}"/>
                </a:ext>
              </a:extLst>
            </p:cNvPr>
            <p:cNvSpPr/>
            <p:nvPr/>
          </p:nvSpPr>
          <p:spPr>
            <a:xfrm>
              <a:off x="4171251" y="3229007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ID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0E3C73B-6D11-8523-08BF-DFBD64AB67AF}"/>
                </a:ext>
              </a:extLst>
            </p:cNvPr>
            <p:cNvSpPr/>
            <p:nvPr/>
          </p:nvSpPr>
          <p:spPr>
            <a:xfrm>
              <a:off x="4414540" y="4018901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UT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018E5B5-ED7A-2FDC-7F51-A1BD168BE661}"/>
                </a:ext>
              </a:extLst>
            </p:cNvPr>
            <p:cNvSpPr/>
            <p:nvPr/>
          </p:nvSpPr>
          <p:spPr>
            <a:xfrm>
              <a:off x="5270898" y="4150306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CO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7C9557A2-DB3B-8950-8CD9-FC913DB336A5}"/>
                </a:ext>
              </a:extLst>
            </p:cNvPr>
            <p:cNvSpPr/>
            <p:nvPr/>
          </p:nvSpPr>
          <p:spPr>
            <a:xfrm>
              <a:off x="6275455" y="4295593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KS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9B3BCA8-D938-16E5-E301-CF9C8DFB518D}"/>
                </a:ext>
              </a:extLst>
            </p:cNvPr>
            <p:cNvSpPr/>
            <p:nvPr/>
          </p:nvSpPr>
          <p:spPr>
            <a:xfrm>
              <a:off x="7236255" y="5597689"/>
              <a:ext cx="199389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LA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F5891FB-3A58-7259-0763-42A77A067247}"/>
                </a:ext>
              </a:extLst>
            </p:cNvPr>
            <p:cNvSpPr/>
            <p:nvPr/>
          </p:nvSpPr>
          <p:spPr>
            <a:xfrm>
              <a:off x="8976288" y="4915826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SC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C59BD5C6-5668-E3DA-B129-92595A8613A7}"/>
                </a:ext>
              </a:extLst>
            </p:cNvPr>
            <p:cNvSpPr/>
            <p:nvPr/>
          </p:nvSpPr>
          <p:spPr>
            <a:xfrm>
              <a:off x="9230186" y="4612369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NC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F3FE085B-3EEA-EF4C-CF57-69066E7F6F11}"/>
                </a:ext>
              </a:extLst>
            </p:cNvPr>
            <p:cNvSpPr/>
            <p:nvPr/>
          </p:nvSpPr>
          <p:spPr>
            <a:xfrm>
              <a:off x="9250608" y="4231132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VA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E6BD68D6-36E6-FF68-3123-6043FEF8580F}"/>
                </a:ext>
              </a:extLst>
            </p:cNvPr>
            <p:cNvSpPr/>
            <p:nvPr/>
          </p:nvSpPr>
          <p:spPr>
            <a:xfrm>
              <a:off x="10165920" y="2699170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ME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33795-158F-8212-4C0B-814C43D0DC00}"/>
                </a:ext>
              </a:extLst>
            </p:cNvPr>
            <p:cNvSpPr/>
            <p:nvPr/>
          </p:nvSpPr>
          <p:spPr>
            <a:xfrm>
              <a:off x="6088049" y="3269185"/>
              <a:ext cx="274320" cy="182880"/>
            </a:xfrm>
            <a:prstGeom prst="rect">
              <a:avLst/>
            </a:prstGeom>
            <a:solidFill>
              <a:srgbClr val="002D7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00"/>
                <a:t>SD</a:t>
              </a:r>
            </a:p>
          </p:txBody>
        </p:sp>
      </p:grp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D61927D2-DB4E-7941-E7BA-A9821477623E}"/>
              </a:ext>
            </a:extLst>
          </p:cNvPr>
          <p:cNvCxnSpPr>
            <a:cxnSpLocks/>
          </p:cNvCxnSpPr>
          <p:nvPr/>
        </p:nvCxnSpPr>
        <p:spPr>
          <a:xfrm>
            <a:off x="397080" y="6141431"/>
            <a:ext cx="9509760" cy="0"/>
          </a:xfrm>
          <a:prstGeom prst="line">
            <a:avLst/>
          </a:prstGeom>
          <a:ln>
            <a:solidFill>
              <a:srgbClr val="071D4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6469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3</Words>
  <Application>Microsoft Macintosh PowerPoint</Application>
  <PresentationFormat>Widescreen</PresentationFormat>
  <Paragraphs>2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Malgun Gothic</vt:lpstr>
      <vt:lpstr>Aptos</vt:lpstr>
      <vt:lpstr>Aptos Display</vt:lpstr>
      <vt:lpstr>Arial</vt:lpstr>
      <vt:lpstr>Office Theme</vt:lpstr>
      <vt:lpstr>Supplementary Figure 1a. HCV treatment rates among RNA-positive patients by age, 2014-2021 Supplementary Figure 1b. HCV treatment rates by FIB-4 score, 2014-2021 Supplementary Figure 1c. HCV treatment rates by HIV co-infection status, 2014-2021 </vt:lpstr>
      <vt:lpstr>Supplementary Figure 2. Percentage of the HCV RNA-Positive Patients Treated in 202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hany, Marc (NIH/NIDDK) [E]</dc:creator>
  <cp:lastModifiedBy>Ghany, Marc (NIH/NIDDK) [E]</cp:lastModifiedBy>
  <cp:revision>1</cp:revision>
  <dcterms:created xsi:type="dcterms:W3CDTF">2025-07-24T02:55:37Z</dcterms:created>
  <dcterms:modified xsi:type="dcterms:W3CDTF">2025-07-24T02:56:41Z</dcterms:modified>
</cp:coreProperties>
</file>